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144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3F9B-2575-4CB0-B173-420061701C7C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B9DDA-4797-42F0-A12F-E6F3699A8A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37704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3F9B-2575-4CB0-B173-420061701C7C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B9DDA-4797-42F0-A12F-E6F3699A8A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16423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3F9B-2575-4CB0-B173-420061701C7C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B9DDA-4797-42F0-A12F-E6F3699A8A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0631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3F9B-2575-4CB0-B173-420061701C7C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B9DDA-4797-42F0-A12F-E6F3699A8A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4065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3F9B-2575-4CB0-B173-420061701C7C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B9DDA-4797-42F0-A12F-E6F3699A8A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6663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3F9B-2575-4CB0-B173-420061701C7C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B9DDA-4797-42F0-A12F-E6F3699A8A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93921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3F9B-2575-4CB0-B173-420061701C7C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B9DDA-4797-42F0-A12F-E6F3699A8A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62141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3F9B-2575-4CB0-B173-420061701C7C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B9DDA-4797-42F0-A12F-E6F3699A8A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17095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3F9B-2575-4CB0-B173-420061701C7C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B9DDA-4797-42F0-A12F-E6F3699A8A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7321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3F9B-2575-4CB0-B173-420061701C7C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B9DDA-4797-42F0-A12F-E6F3699A8A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8114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3F9B-2575-4CB0-B173-420061701C7C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B9DDA-4797-42F0-A12F-E6F3699A8A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1918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B13F9B-2575-4CB0-B173-420061701C7C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CB9DDA-4797-42F0-A12F-E6F3699A8A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76728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38BC5BE5-1BB9-49E5-AB60-3D1A2B1AC6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426" y="256315"/>
            <a:ext cx="8476831" cy="4827238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8BE616E9-DD2A-4CFF-AA1A-420D2D67BB3A}"/>
              </a:ext>
            </a:extLst>
          </p:cNvPr>
          <p:cNvSpPr txBox="1"/>
          <p:nvPr/>
        </p:nvSpPr>
        <p:spPr>
          <a:xfrm>
            <a:off x="92181" y="5828280"/>
            <a:ext cx="895963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Figure S 2: Results of amino acid sequence homology alignment of G. </a:t>
            </a:r>
            <a:r>
              <a:rPr lang="en-US" altLang="zh-CN" dirty="0" err="1"/>
              <a:t>pentaphyllum</a:t>
            </a:r>
            <a:r>
              <a:rPr lang="en-US" altLang="zh-CN" dirty="0"/>
              <a:t> UGTs. </a:t>
            </a:r>
          </a:p>
          <a:p>
            <a:r>
              <a:rPr lang="en-US" altLang="zh-CN" dirty="0"/>
              <a:t>The black box is the glycosyltransferase PSPG motif.</a:t>
            </a:r>
          </a:p>
        </p:txBody>
      </p:sp>
    </p:spTree>
    <p:extLst>
      <p:ext uri="{BB962C8B-B14F-4D97-AF65-F5344CB8AC3E}">
        <p14:creationId xmlns:p14="http://schemas.microsoft.com/office/powerpoint/2010/main" val="37660269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26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 Qicong</dc:creator>
  <cp:lastModifiedBy>HYD OFF33</cp:lastModifiedBy>
  <cp:revision>3</cp:revision>
  <dcterms:created xsi:type="dcterms:W3CDTF">2021-03-16T01:14:08Z</dcterms:created>
  <dcterms:modified xsi:type="dcterms:W3CDTF">2021-11-16T01:53:46Z</dcterms:modified>
</cp:coreProperties>
</file>